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ppt/comments/comment2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1" r:id="rId5"/>
    <p:sldId id="258" r:id="rId6"/>
    <p:sldId id="259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rris, Jennifer S." initials="FJS" lastIdx="2" clrIdx="0">
    <p:extLst>
      <p:ext uri="{19B8F6BF-5375-455C-9EA6-DF929625EA0E}">
        <p15:presenceInfo xmlns:p15="http://schemas.microsoft.com/office/powerpoint/2012/main" userId="S-1-5-21-2268474175-859333071-1483869524-1372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8" d="100"/>
          <a:sy n="68" d="100"/>
        </p:scale>
        <p:origin x="45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4-09-18T11:03:43.162" idx="1">
    <p:pos x="7125" y="757"/>
    <p:text>For consistency maybe say "Endometrial cancer"</p:text>
    <p:extLst mod="1">
      <p:ext uri="{C676402C-5697-4E1C-873F-D02D1690AC5C}">
        <p15:threadingInfo xmlns:p15="http://schemas.microsoft.com/office/powerpoint/2012/main" timeZoneBias="240"/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4-09-18T18:06:19.077" idx="2">
    <p:pos x="7356" y="684"/>
    <p:text>Think this should be Endometrioid</p:text>
    <p:extLst mod="1">
      <p:ext uri="{C676402C-5697-4E1C-873F-D02D1690AC5C}">
        <p15:threadingInfo xmlns:p15="http://schemas.microsoft.com/office/powerpoint/2012/main" timeZoneBias="240"/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A2154D-9316-46FA-875E-DE2BDDC12B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E8753A-2B23-4811-890D-C1B687FE4E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6B6105-8C22-43F9-9896-C22BC4752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98B4C2-819E-4E25-B9A4-770B6763C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34813-4A33-4A8F-A2ED-C9B52CF21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635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E9DC4-0F40-4C48-BD3B-2EF6ED85EC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584BDD-DF25-47EA-A2CB-F5A9C318E7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132C79-6F56-4AB3-B03C-6D83F26B1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B8F2EB-DF0C-47D9-B3A7-80B9D132A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CAA17B-B244-4A5D-8A76-2D7D2734F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334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4442EA-9A11-4B4D-B212-AED7D22324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B12CBC-11D7-4511-861E-3F7D118499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5CA951-9041-423F-A60A-FCFD648E1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E33746-E39F-4E0C-A7B3-6331AC333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096D7F-2E0A-4F87-BC2C-2E1723AD7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13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729528-EFD0-4927-AE3D-19BBAE42A8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B5420C-7500-4B14-AE1D-15D114FF6C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A4AFA-1C7E-4392-8D8F-75254F52D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ADBE9A-5527-4C4E-BD0B-F5728BFCC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21801C-85A2-47E3-9A0E-8757592AA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012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064D8-9000-4D5C-A8F8-630D5B9AC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0FD641-C0D2-4672-9671-BCDD0C073F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1D94B-C426-436F-BB85-9B754C5D5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4B1CEB-A8B1-485E-B230-C3BDA480C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87D1F8-6F4D-4164-880E-A5C2265EC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397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9AF469-636B-49B1-8499-90F8C3202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657AAB-E02E-472E-AC57-7E64B18461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C9CF87-9DBF-461E-B77E-5165FC2F43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C6F760-A388-495F-97A0-C7FB70F4A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BE9B7F-3AE1-40A6-BDD5-885E859A3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7FB521-CF3A-4AF1-B0FA-5BBFBA85B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58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3FD0AC-F6E9-49AA-AC74-3D357D621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5F6B27-A19D-4680-AB8B-C5173454F1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89A1A6-6D98-4D39-83E5-0806CAB421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BAC99F-E4C0-4FF6-B68E-7855640A9A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980CBA-9C5B-44EB-85C4-B959299A98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3D4A01-CB19-4976-8364-4B76BD87B9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5FB3D4-DAFA-440F-A9C8-F67CCE6B7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E0CCD7-0D87-4E8C-A889-77061CE6C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090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42992-532D-485F-8CDE-52F661960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3FAA5D7-110B-48AA-9A35-0C315277D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0225CA-4656-405B-AB5D-35514E638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4AE253D-4590-474D-AE80-30E689FAF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218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EA655C-3B22-4821-B843-C538BCAC0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DEC225D-B975-4ACA-9830-4ED5ADE7A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F079B0D-CA76-45ED-AFD5-BCB70E8CA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789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9FFC20-5107-40FA-BA96-6EBC56A1E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6E60A8-DCD8-4682-8C8D-751F2A5FB1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8A531D-4414-4E52-8D8B-83482501E6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C48FFA-826E-406C-96E5-91DECD199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477C67-6042-4BE1-B14F-6495FD9C7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FF3D45-6414-466E-9C70-521108195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813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10823B-ABC2-47D3-976F-115B5575E0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E5AE13F-E775-4F8B-B37E-0349205820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74504B-D987-4703-9387-53845FE6A3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9C3833-001C-4F00-83CA-771F500B3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20A9D8-C4EF-4792-8F89-A853A4F93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2FC00C-BEA2-4C5C-95F7-32DF11C47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102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A4D3B3-5736-4B91-BDBE-825CA9D46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E5FF52-2244-41D6-9CFA-3EF777F04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A78AC8-07C2-492E-84FB-6BE0C2E02E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8B21D-55B9-4031-9DA5-766D086C0392}" type="datetimeFigureOut">
              <a:rPr lang="en-US" smtClean="0"/>
              <a:t>9/2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2FEF27-BED2-40E5-93D7-6DD1E95221C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163557-083F-4B91-A144-2F79D2BA24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53508-1683-4A48-BC26-054018F31B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99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omments" Target="../comments/commen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omments" Target="../comments/comment2.xml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88485C6E-E80B-4F06-8625-B376A13AA336}"/>
              </a:ext>
            </a:extLst>
          </p:cNvPr>
          <p:cNvSpPr/>
          <p:nvPr/>
        </p:nvSpPr>
        <p:spPr>
          <a:xfrm>
            <a:off x="458238" y="311220"/>
            <a:ext cx="23193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l Figure 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62DBFE8-4B77-4651-BF8C-C7FBCEB7042D}"/>
              </a:ext>
            </a:extLst>
          </p:cNvPr>
          <p:cNvSpPr/>
          <p:nvPr/>
        </p:nvSpPr>
        <p:spPr>
          <a:xfrm>
            <a:off x="2966973" y="1947473"/>
            <a:ext cx="5053098" cy="261585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Excluded: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-- Cancer histology not in </a:t>
            </a:r>
            <a:r>
              <a:rPr lang="en-US" sz="1400" dirty="0" err="1">
                <a:solidFill>
                  <a:schemeClr val="tx1"/>
                </a:solidFill>
                <a:latin typeface="Calibri" panose="020F0502020204030204" pitchFamily="34" charset="0"/>
              </a:rPr>
              <a:t>endometroid</a:t>
            </a:r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, serous, clear cell, carcinosarcoma (N = 35,466)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 -- Cancer stage not in stage 4, 4A, 4B (N = 485,516)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 -- Not first primary cancer (N = 3,750)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 -- Diagnosis not confirmed pathologically (N = 1,296)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-- Missing chemotherapy initiation day and surgery day (N = 5,482)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-- Had chemotherapy and debulking surgery initiated on the same day (N = 23)</a:t>
            </a:r>
          </a:p>
          <a:p>
            <a:r>
              <a:rPr lang="en-US" sz="1400" dirty="0">
                <a:solidFill>
                  <a:schemeClr val="tx1"/>
                </a:solidFill>
                <a:latin typeface="Calibri" panose="020F0502020204030204" pitchFamily="34" charset="0"/>
              </a:rPr>
              <a:t>-- Did not have sufficient information to determine chemotherapy and surgery sequence  (N = 1,516)</a:t>
            </a:r>
          </a:p>
          <a:p>
            <a:endParaRPr lang="en-US" sz="1400" dirty="0">
              <a:solidFill>
                <a:schemeClr val="tx1"/>
              </a:solidFill>
              <a:latin typeface="Calibri" panose="020F050202020403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B50A259A-A863-48D6-B3CE-22741DBF2EDB}"/>
              </a:ext>
            </a:extLst>
          </p:cNvPr>
          <p:cNvGrpSpPr/>
          <p:nvPr/>
        </p:nvGrpSpPr>
        <p:grpSpPr>
          <a:xfrm>
            <a:off x="569276" y="799912"/>
            <a:ext cx="4237318" cy="5481619"/>
            <a:chOff x="1562039" y="2083639"/>
            <a:chExt cx="4237318" cy="5481619"/>
          </a:xfrm>
        </p:grpSpPr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238DD43F-D196-4F6A-8691-79F917821A3B}"/>
                </a:ext>
              </a:extLst>
            </p:cNvPr>
            <p:cNvCxnSpPr>
              <a:cxnSpLocks/>
              <a:stCxn id="10" idx="2"/>
              <a:endCxn id="11" idx="0"/>
            </p:cNvCxnSpPr>
            <p:nvPr/>
          </p:nvCxnSpPr>
          <p:spPr>
            <a:xfrm>
              <a:off x="3680698" y="2754191"/>
              <a:ext cx="3582" cy="356987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Rectangle: Rounded Corners 9">
              <a:extLst>
                <a:ext uri="{FF2B5EF4-FFF2-40B4-BE49-F238E27FC236}">
                  <a16:creationId xmlns:a16="http://schemas.microsoft.com/office/drawing/2014/main" id="{BA1886B8-71FF-4D33-AADC-169523B5B958}"/>
                </a:ext>
              </a:extLst>
            </p:cNvPr>
            <p:cNvSpPr/>
            <p:nvPr/>
          </p:nvSpPr>
          <p:spPr>
            <a:xfrm>
              <a:off x="1562039" y="2083639"/>
              <a:ext cx="4237318" cy="67055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Endometrial cancer patients in NCDB: 2010-2021</a:t>
              </a:r>
            </a:p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(N = 551,254)</a:t>
              </a:r>
            </a:p>
          </p:txBody>
        </p:sp>
        <p:sp>
          <p:nvSpPr>
            <p:cNvPr id="11" name="Rectangle: Rounded Corners 10">
              <a:extLst>
                <a:ext uri="{FF2B5EF4-FFF2-40B4-BE49-F238E27FC236}">
                  <a16:creationId xmlns:a16="http://schemas.microsoft.com/office/drawing/2014/main" id="{5E981EEC-2308-4DC9-A208-1EEE43465752}"/>
                </a:ext>
              </a:extLst>
            </p:cNvPr>
            <p:cNvSpPr/>
            <p:nvPr/>
          </p:nvSpPr>
          <p:spPr>
            <a:xfrm>
              <a:off x="1875359" y="6324066"/>
              <a:ext cx="3617842" cy="1241192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Stage 4/4a/4b patients with histologic types of endometroid, serous, clear cell, and carcinosarcoma</a:t>
              </a:r>
            </a:p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-- Trend analysis cohort (N=18,205) </a:t>
              </a:r>
            </a:p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-- Survival analysis cohort (N=16,450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91778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913C4E-0287-4903-98AE-E991E3449A86}"/>
              </a:ext>
            </a:extLst>
          </p:cNvPr>
          <p:cNvSpPr txBox="1"/>
          <p:nvPr/>
        </p:nvSpPr>
        <p:spPr>
          <a:xfrm>
            <a:off x="494951" y="453006"/>
            <a:ext cx="24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2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8F2F485-E1E1-4C44-928A-349BD7B10569}"/>
              </a:ext>
            </a:extLst>
          </p:cNvPr>
          <p:cNvSpPr txBox="1"/>
          <p:nvPr/>
        </p:nvSpPr>
        <p:spPr>
          <a:xfrm>
            <a:off x="896172" y="964204"/>
            <a:ext cx="23299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. Intention-to-treat analysi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64B0DE-D25B-4E0F-93BD-D8599F792B6B}"/>
              </a:ext>
            </a:extLst>
          </p:cNvPr>
          <p:cNvSpPr txBox="1"/>
          <p:nvPr/>
        </p:nvSpPr>
        <p:spPr>
          <a:xfrm>
            <a:off x="5957422" y="964204"/>
            <a:ext cx="19327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. Per-protocol analysis</a:t>
            </a:r>
          </a:p>
        </p:txBody>
      </p:sp>
      <p:pic>
        <p:nvPicPr>
          <p:cNvPr id="8" name="Picture 7" descr="The SGPlot Procedure">
            <a:extLst>
              <a:ext uri="{FF2B5EF4-FFF2-40B4-BE49-F238E27FC236}">
                <a16:creationId xmlns:a16="http://schemas.microsoft.com/office/drawing/2014/main" id="{788E1185-05D2-4702-9DB3-0FE8D77E569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0" t="2028" r="995" b="15347"/>
          <a:stretch/>
        </p:blipFill>
        <p:spPr bwMode="auto">
          <a:xfrm>
            <a:off x="6008914" y="1473612"/>
            <a:ext cx="4559081" cy="33449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7" name="Group 16">
            <a:extLst>
              <a:ext uri="{FF2B5EF4-FFF2-40B4-BE49-F238E27FC236}">
                <a16:creationId xmlns:a16="http://schemas.microsoft.com/office/drawing/2014/main" id="{AD365B06-B16F-476B-AD88-66618C6F59A1}"/>
              </a:ext>
            </a:extLst>
          </p:cNvPr>
          <p:cNvGrpSpPr/>
          <p:nvPr/>
        </p:nvGrpSpPr>
        <p:grpSpPr>
          <a:xfrm>
            <a:off x="896172" y="1478875"/>
            <a:ext cx="4610589" cy="3587539"/>
            <a:chOff x="482013" y="1473612"/>
            <a:chExt cx="4610589" cy="3587539"/>
          </a:xfrm>
        </p:grpSpPr>
        <p:pic>
          <p:nvPicPr>
            <p:cNvPr id="7" name="Picture 6" descr="The SGPlot Procedure">
              <a:extLst>
                <a:ext uri="{FF2B5EF4-FFF2-40B4-BE49-F238E27FC236}">
                  <a16:creationId xmlns:a16="http://schemas.microsoft.com/office/drawing/2014/main" id="{2C480B53-CC1D-49AF-807D-0EBC7E67272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00" t="2087" r="1142" b="12380"/>
            <a:stretch/>
          </p:blipFill>
          <p:spPr bwMode="auto">
            <a:xfrm>
              <a:off x="768097" y="1473612"/>
              <a:ext cx="4324505" cy="33449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4A59302-C550-4DC2-AADA-D8C89412AC41}"/>
                </a:ext>
              </a:extLst>
            </p:cNvPr>
            <p:cNvSpPr txBox="1"/>
            <p:nvPr/>
          </p:nvSpPr>
          <p:spPr>
            <a:xfrm>
              <a:off x="1325552" y="4784152"/>
              <a:ext cx="37582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Time From Diagnosis to Last Contact or Death (Months) 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5AE5F0D-71CC-4C07-AC1E-7E14C2889B5F}"/>
                </a:ext>
              </a:extLst>
            </p:cNvPr>
            <p:cNvSpPr txBox="1"/>
            <p:nvPr/>
          </p:nvSpPr>
          <p:spPr>
            <a:xfrm rot="16200000">
              <a:off x="-324201" y="2989383"/>
              <a:ext cx="1889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Survival Function Estimate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0DA14916-0C9E-4E80-8E3C-FB76C187E4B5}"/>
              </a:ext>
            </a:extLst>
          </p:cNvPr>
          <p:cNvSpPr txBox="1"/>
          <p:nvPr/>
        </p:nvSpPr>
        <p:spPr>
          <a:xfrm>
            <a:off x="6573827" y="4818596"/>
            <a:ext cx="3758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ime From Diagnosis to Last Contact or Death (Months)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B817C33-3F84-4F08-9309-022E1B990669}"/>
              </a:ext>
            </a:extLst>
          </p:cNvPr>
          <p:cNvSpPr txBox="1"/>
          <p:nvPr/>
        </p:nvSpPr>
        <p:spPr>
          <a:xfrm rot="16200000">
            <a:off x="4940193" y="3007605"/>
            <a:ext cx="1889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rvival Function Estimate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9B2DD078-4646-4418-BA34-194B32F51EB7}"/>
              </a:ext>
            </a:extLst>
          </p:cNvPr>
          <p:cNvGrpSpPr/>
          <p:nvPr/>
        </p:nvGrpSpPr>
        <p:grpSpPr>
          <a:xfrm>
            <a:off x="2548102" y="5334832"/>
            <a:ext cx="7551226" cy="270075"/>
            <a:chOff x="2023668" y="5477857"/>
            <a:chExt cx="7551226" cy="270075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4304C28E-0AAC-4536-B224-56EAEC757173}"/>
                </a:ext>
              </a:extLst>
            </p:cNvPr>
            <p:cNvGrpSpPr/>
            <p:nvPr/>
          </p:nvGrpSpPr>
          <p:grpSpPr>
            <a:xfrm>
              <a:off x="2023668" y="5486322"/>
              <a:ext cx="3782147" cy="261610"/>
              <a:chOff x="1811948" y="5700715"/>
              <a:chExt cx="3782147" cy="261610"/>
            </a:xfrm>
          </p:grpSpPr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1CCA03EA-18D2-4189-BFD8-106B7980738C}"/>
                  </a:ext>
                </a:extLst>
              </p:cNvPr>
              <p:cNvCxnSpPr/>
              <p:nvPr/>
            </p:nvCxnSpPr>
            <p:spPr>
              <a:xfrm>
                <a:off x="1811948" y="5831520"/>
                <a:ext cx="226048" cy="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0863BC7-8359-4F2E-AA8D-39405ADE66D2}"/>
                  </a:ext>
                </a:extLst>
              </p:cNvPr>
              <p:cNvSpPr txBox="1"/>
              <p:nvPr/>
            </p:nvSpPr>
            <p:spPr>
              <a:xfrm>
                <a:off x="1992021" y="5700715"/>
                <a:ext cx="36020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rimary Surgery Followed by Chemotherapy 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F566DF93-029E-491C-8E0F-7E671E093CE3}"/>
                </a:ext>
              </a:extLst>
            </p:cNvPr>
            <p:cNvGrpSpPr/>
            <p:nvPr/>
          </p:nvGrpSpPr>
          <p:grpSpPr>
            <a:xfrm>
              <a:off x="5442348" y="5477857"/>
              <a:ext cx="4132546" cy="261610"/>
              <a:chOff x="1823637" y="5930098"/>
              <a:chExt cx="4132546" cy="261610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1A51E4E5-40F7-457E-BCAE-0F3D58F7E618}"/>
                  </a:ext>
                </a:extLst>
              </p:cNvPr>
              <p:cNvSpPr txBox="1"/>
              <p:nvPr/>
            </p:nvSpPr>
            <p:spPr>
              <a:xfrm>
                <a:off x="1974767" y="5930098"/>
                <a:ext cx="398141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Neoadjuvant Chemotherapy Followed by Surgery </a:t>
                </a:r>
              </a:p>
            </p:txBody>
          </p: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A50B0403-46C3-4B0B-856D-DCC7667111A6}"/>
                  </a:ext>
                </a:extLst>
              </p:cNvPr>
              <p:cNvCxnSpPr/>
              <p:nvPr/>
            </p:nvCxnSpPr>
            <p:spPr>
              <a:xfrm>
                <a:off x="1823637" y="6060903"/>
                <a:ext cx="226048" cy="0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9766620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8F2F485-E1E1-4C44-928A-349BD7B10569}"/>
              </a:ext>
            </a:extLst>
          </p:cNvPr>
          <p:cNvSpPr txBox="1"/>
          <p:nvPr/>
        </p:nvSpPr>
        <p:spPr>
          <a:xfrm>
            <a:off x="3492782" y="411389"/>
            <a:ext cx="10303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. Stage 4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64B0DE-D25B-4E0F-93BD-D8599F792B6B}"/>
              </a:ext>
            </a:extLst>
          </p:cNvPr>
          <p:cNvSpPr txBox="1"/>
          <p:nvPr/>
        </p:nvSpPr>
        <p:spPr>
          <a:xfrm>
            <a:off x="7775523" y="490164"/>
            <a:ext cx="1012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. Stage 4B</a:t>
            </a:r>
          </a:p>
        </p:txBody>
      </p:sp>
      <p:pic>
        <p:nvPicPr>
          <p:cNvPr id="8" name="Picture 7" descr="The SGPlot Procedure">
            <a:extLst>
              <a:ext uri="{FF2B5EF4-FFF2-40B4-BE49-F238E27FC236}">
                <a16:creationId xmlns:a16="http://schemas.microsoft.com/office/drawing/2014/main" id="{AA3813FA-BAF7-4B4B-83A9-7AB68F86D73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6" t="2149" r="1312" b="13341"/>
          <a:stretch/>
        </p:blipFill>
        <p:spPr bwMode="auto">
          <a:xfrm>
            <a:off x="3589111" y="815311"/>
            <a:ext cx="3067050" cy="23395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ABF64B7-68DD-4C1F-A5B1-571FC49EADD9}"/>
              </a:ext>
            </a:extLst>
          </p:cNvPr>
          <p:cNvSpPr txBox="1"/>
          <p:nvPr/>
        </p:nvSpPr>
        <p:spPr>
          <a:xfrm>
            <a:off x="928183" y="1680932"/>
            <a:ext cx="18376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tention-to-treat</a:t>
            </a:r>
          </a:p>
        </p:txBody>
      </p:sp>
      <p:pic>
        <p:nvPicPr>
          <p:cNvPr id="9" name="Picture 8" descr="The SGPlot Procedure">
            <a:extLst>
              <a:ext uri="{FF2B5EF4-FFF2-40B4-BE49-F238E27FC236}">
                <a16:creationId xmlns:a16="http://schemas.microsoft.com/office/drawing/2014/main" id="{591CC951-A941-418F-80F3-E16587B3FDB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7" t="1249" r="1312" b="12392"/>
          <a:stretch/>
        </p:blipFill>
        <p:spPr bwMode="auto">
          <a:xfrm>
            <a:off x="7790886" y="854877"/>
            <a:ext cx="3067050" cy="2390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3FBEB03-4A64-4B4C-AF92-A161A47400EE}"/>
              </a:ext>
            </a:extLst>
          </p:cNvPr>
          <p:cNvSpPr txBox="1"/>
          <p:nvPr/>
        </p:nvSpPr>
        <p:spPr>
          <a:xfrm>
            <a:off x="1015455" y="4246099"/>
            <a:ext cx="135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r-protocol</a:t>
            </a:r>
          </a:p>
        </p:txBody>
      </p:sp>
      <p:pic>
        <p:nvPicPr>
          <p:cNvPr id="11" name="Picture 10" descr="The SGPlot Procedure">
            <a:extLst>
              <a:ext uri="{FF2B5EF4-FFF2-40B4-BE49-F238E27FC236}">
                <a16:creationId xmlns:a16="http://schemas.microsoft.com/office/drawing/2014/main" id="{DADDE7C7-066F-4ACE-BF41-37EAFF7E5C3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0" t="2149" r="873" b="16187"/>
          <a:stretch/>
        </p:blipFill>
        <p:spPr bwMode="auto">
          <a:xfrm>
            <a:off x="3555457" y="3720089"/>
            <a:ext cx="3244871" cy="23613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1" descr="The SGPlot Procedure">
            <a:extLst>
              <a:ext uri="{FF2B5EF4-FFF2-40B4-BE49-F238E27FC236}">
                <a16:creationId xmlns:a16="http://schemas.microsoft.com/office/drawing/2014/main" id="{222B4FB2-D988-43A1-ABFF-98FC0C61DE1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5" t="1841" r="1055" b="15239"/>
          <a:stretch/>
        </p:blipFill>
        <p:spPr bwMode="auto">
          <a:xfrm>
            <a:off x="7802927" y="3625404"/>
            <a:ext cx="3199275" cy="2390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D786013-3B21-459D-9B1C-03359E298C20}"/>
              </a:ext>
            </a:extLst>
          </p:cNvPr>
          <p:cNvSpPr txBox="1"/>
          <p:nvPr/>
        </p:nvSpPr>
        <p:spPr>
          <a:xfrm>
            <a:off x="3526830" y="3154889"/>
            <a:ext cx="3758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ime From Diagnosis to Last Contact or Death (Months)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FCD3536-2158-42C7-B561-3B9039DD91F6}"/>
              </a:ext>
            </a:extLst>
          </p:cNvPr>
          <p:cNvSpPr txBox="1"/>
          <p:nvPr/>
        </p:nvSpPr>
        <p:spPr>
          <a:xfrm>
            <a:off x="7790886" y="3157712"/>
            <a:ext cx="3758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ime From Diagnosis to Last Contact or Death (Months)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C2E277B-1DBB-4002-82E3-D39A62787548}"/>
              </a:ext>
            </a:extLst>
          </p:cNvPr>
          <p:cNvSpPr txBox="1"/>
          <p:nvPr/>
        </p:nvSpPr>
        <p:spPr>
          <a:xfrm>
            <a:off x="7775523" y="6059013"/>
            <a:ext cx="3758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ime From Diagnosis to Last Contact or Death (Months) 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3904A-A872-4D62-9E0C-06B4EEBE1447}"/>
              </a:ext>
            </a:extLst>
          </p:cNvPr>
          <p:cNvSpPr txBox="1"/>
          <p:nvPr/>
        </p:nvSpPr>
        <p:spPr>
          <a:xfrm>
            <a:off x="3589111" y="6016179"/>
            <a:ext cx="3758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ime From Diagnosis to Last Contact or Death (Months)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F99311D-0CD0-4C06-8F24-F46518C02D0E}"/>
              </a:ext>
            </a:extLst>
          </p:cNvPr>
          <p:cNvSpPr txBox="1"/>
          <p:nvPr/>
        </p:nvSpPr>
        <p:spPr>
          <a:xfrm rot="16200000">
            <a:off x="6707673" y="1888539"/>
            <a:ext cx="18894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rvival Function Estimat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A7DAEBD-0C1A-49F2-ABB4-140F3864E253}"/>
              </a:ext>
            </a:extLst>
          </p:cNvPr>
          <p:cNvSpPr txBox="1"/>
          <p:nvPr/>
        </p:nvSpPr>
        <p:spPr>
          <a:xfrm rot="16200000">
            <a:off x="2409568" y="1785157"/>
            <a:ext cx="1889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rvival Function Estimat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1881CDA-CE2F-4F16-8964-5E5234819E4F}"/>
              </a:ext>
            </a:extLst>
          </p:cNvPr>
          <p:cNvSpPr txBox="1"/>
          <p:nvPr/>
        </p:nvSpPr>
        <p:spPr>
          <a:xfrm rot="16200000">
            <a:off x="6692310" y="4682291"/>
            <a:ext cx="1889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rvival Function Estimat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254BF3-DD84-4E96-AFB3-57FF799C997B}"/>
              </a:ext>
            </a:extLst>
          </p:cNvPr>
          <p:cNvSpPr txBox="1"/>
          <p:nvPr/>
        </p:nvSpPr>
        <p:spPr>
          <a:xfrm rot="16200000">
            <a:off x="2409569" y="4780992"/>
            <a:ext cx="1889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rvival Function Estimate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7E3D1418-D4F5-414C-80BA-ACA35C639CC9}"/>
              </a:ext>
            </a:extLst>
          </p:cNvPr>
          <p:cNvGrpSpPr/>
          <p:nvPr/>
        </p:nvGrpSpPr>
        <p:grpSpPr>
          <a:xfrm>
            <a:off x="3589111" y="6313864"/>
            <a:ext cx="7551226" cy="270075"/>
            <a:chOff x="2023668" y="5477857"/>
            <a:chExt cx="7551226" cy="270075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666A738F-5E57-4F03-A584-7439A838E4BC}"/>
                </a:ext>
              </a:extLst>
            </p:cNvPr>
            <p:cNvGrpSpPr/>
            <p:nvPr/>
          </p:nvGrpSpPr>
          <p:grpSpPr>
            <a:xfrm>
              <a:off x="2023668" y="5486322"/>
              <a:ext cx="3782147" cy="261610"/>
              <a:chOff x="1811948" y="5700715"/>
              <a:chExt cx="3782147" cy="261610"/>
            </a:xfrm>
          </p:grpSpPr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9F972B22-CE20-43DD-B0BF-3DD4A72250D4}"/>
                  </a:ext>
                </a:extLst>
              </p:cNvPr>
              <p:cNvCxnSpPr/>
              <p:nvPr/>
            </p:nvCxnSpPr>
            <p:spPr>
              <a:xfrm>
                <a:off x="1811948" y="5831520"/>
                <a:ext cx="226048" cy="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091A969-F69A-48AC-AB69-D53DD9238362}"/>
                  </a:ext>
                </a:extLst>
              </p:cNvPr>
              <p:cNvSpPr txBox="1"/>
              <p:nvPr/>
            </p:nvSpPr>
            <p:spPr>
              <a:xfrm>
                <a:off x="1992021" y="5700715"/>
                <a:ext cx="36020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rimary Surgery Followed by Chemotherapy </a:t>
                </a: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CD135F28-C858-4B1B-800F-B05B61E7AF5C}"/>
                </a:ext>
              </a:extLst>
            </p:cNvPr>
            <p:cNvGrpSpPr/>
            <p:nvPr/>
          </p:nvGrpSpPr>
          <p:grpSpPr>
            <a:xfrm>
              <a:off x="5442348" y="5477857"/>
              <a:ext cx="4132546" cy="261610"/>
              <a:chOff x="1823637" y="5930098"/>
              <a:chExt cx="4132546" cy="261610"/>
            </a:xfrm>
          </p:grpSpPr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8CB88ABD-B64F-4060-BEBC-35B209DB15D5}"/>
                  </a:ext>
                </a:extLst>
              </p:cNvPr>
              <p:cNvSpPr txBox="1"/>
              <p:nvPr/>
            </p:nvSpPr>
            <p:spPr>
              <a:xfrm>
                <a:off x="1974767" y="5930098"/>
                <a:ext cx="398141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Neoadjuvant Chemotherapy Followed by Surgery </a:t>
                </a:r>
              </a:p>
            </p:txBody>
          </p: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0460C3EF-76C2-4EEB-B8C8-4D8D64ED6626}"/>
                  </a:ext>
                </a:extLst>
              </p:cNvPr>
              <p:cNvCxnSpPr/>
              <p:nvPr/>
            </p:nvCxnSpPr>
            <p:spPr>
              <a:xfrm>
                <a:off x="1823637" y="6060903"/>
                <a:ext cx="226048" cy="0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3B0460AD-6867-4ED6-BA4C-2F4CA86947CD}"/>
              </a:ext>
            </a:extLst>
          </p:cNvPr>
          <p:cNvSpPr txBox="1"/>
          <p:nvPr/>
        </p:nvSpPr>
        <p:spPr>
          <a:xfrm>
            <a:off x="605782" y="189296"/>
            <a:ext cx="24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3. </a:t>
            </a:r>
          </a:p>
        </p:txBody>
      </p:sp>
    </p:spTree>
    <p:extLst>
      <p:ext uri="{BB962C8B-B14F-4D97-AF65-F5344CB8AC3E}">
        <p14:creationId xmlns:p14="http://schemas.microsoft.com/office/powerpoint/2010/main" val="27763568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913C4E-0287-4903-98AE-E991E3449A86}"/>
              </a:ext>
            </a:extLst>
          </p:cNvPr>
          <p:cNvSpPr txBox="1"/>
          <p:nvPr/>
        </p:nvSpPr>
        <p:spPr>
          <a:xfrm>
            <a:off x="480883" y="59111"/>
            <a:ext cx="2433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4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8F2F485-E1E1-4C44-928A-349BD7B10569}"/>
              </a:ext>
            </a:extLst>
          </p:cNvPr>
          <p:cNvSpPr txBox="1"/>
          <p:nvPr/>
        </p:nvSpPr>
        <p:spPr>
          <a:xfrm>
            <a:off x="1551208" y="402881"/>
            <a:ext cx="1403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. Endometrioi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D64B0DE-D25B-4E0F-93BD-D8599F792B6B}"/>
              </a:ext>
            </a:extLst>
          </p:cNvPr>
          <p:cNvSpPr txBox="1"/>
          <p:nvPr/>
        </p:nvSpPr>
        <p:spPr>
          <a:xfrm>
            <a:off x="4395578" y="424954"/>
            <a:ext cx="8749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. Serou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ABF64B7-68DD-4C1F-A5B1-571FC49EADD9}"/>
              </a:ext>
            </a:extLst>
          </p:cNvPr>
          <p:cNvSpPr txBox="1"/>
          <p:nvPr/>
        </p:nvSpPr>
        <p:spPr>
          <a:xfrm>
            <a:off x="0" y="1420837"/>
            <a:ext cx="147527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Intention-to-treat</a:t>
            </a:r>
          </a:p>
          <a:p>
            <a:pPr algn="ctr"/>
            <a:r>
              <a:rPr lang="en-US" sz="1400" dirty="0"/>
              <a:t>analysi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3FBEB03-4A64-4B4C-AF92-A161A47400EE}"/>
              </a:ext>
            </a:extLst>
          </p:cNvPr>
          <p:cNvSpPr txBox="1"/>
          <p:nvPr/>
        </p:nvSpPr>
        <p:spPr>
          <a:xfrm>
            <a:off x="94577" y="3810001"/>
            <a:ext cx="109350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Per-protocol</a:t>
            </a:r>
          </a:p>
          <a:p>
            <a:pPr algn="ctr"/>
            <a:r>
              <a:rPr lang="en-US" sz="1400" dirty="0"/>
              <a:t>analysis</a:t>
            </a:r>
          </a:p>
        </p:txBody>
      </p:sp>
      <p:pic>
        <p:nvPicPr>
          <p:cNvPr id="11" name="Picture 10" descr="The SGPlot Procedure">
            <a:extLst>
              <a:ext uri="{FF2B5EF4-FFF2-40B4-BE49-F238E27FC236}">
                <a16:creationId xmlns:a16="http://schemas.microsoft.com/office/drawing/2014/main" id="{74EFA8E2-80A1-4E80-B4B9-B97C11B2521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4" t="551" r="1945" b="12311"/>
          <a:stretch/>
        </p:blipFill>
        <p:spPr bwMode="auto">
          <a:xfrm>
            <a:off x="1613196" y="681652"/>
            <a:ext cx="2620260" cy="2061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1" descr="The SGPlot Procedure">
            <a:extLst>
              <a:ext uri="{FF2B5EF4-FFF2-40B4-BE49-F238E27FC236}">
                <a16:creationId xmlns:a16="http://schemas.microsoft.com/office/drawing/2014/main" id="{A6C55648-33E7-4C03-9D6A-CA1B47C80D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3" t="2314" r="1434" b="13441"/>
          <a:stretch/>
        </p:blipFill>
        <p:spPr bwMode="auto">
          <a:xfrm>
            <a:off x="4482168" y="724059"/>
            <a:ext cx="2647295" cy="20191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AE1595B-BCF6-4DAD-A9C2-B762CB50804C}"/>
              </a:ext>
            </a:extLst>
          </p:cNvPr>
          <p:cNvSpPr txBox="1"/>
          <p:nvPr/>
        </p:nvSpPr>
        <p:spPr>
          <a:xfrm>
            <a:off x="7308144" y="421885"/>
            <a:ext cx="15508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. Carcinosarcoma</a:t>
            </a:r>
          </a:p>
        </p:txBody>
      </p:sp>
      <p:pic>
        <p:nvPicPr>
          <p:cNvPr id="15" name="Picture 14" descr="The SGPlot Procedure">
            <a:extLst>
              <a:ext uri="{FF2B5EF4-FFF2-40B4-BE49-F238E27FC236}">
                <a16:creationId xmlns:a16="http://schemas.microsoft.com/office/drawing/2014/main" id="{40969436-1085-4767-BC53-0538D810874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28" t="2196" r="1924" b="12510"/>
          <a:stretch/>
        </p:blipFill>
        <p:spPr bwMode="auto">
          <a:xfrm>
            <a:off x="7415212" y="719138"/>
            <a:ext cx="2652123" cy="2061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5" descr="The SGPlot Procedure">
            <a:extLst>
              <a:ext uri="{FF2B5EF4-FFF2-40B4-BE49-F238E27FC236}">
                <a16:creationId xmlns:a16="http://schemas.microsoft.com/office/drawing/2014/main" id="{D8497E78-F27B-466C-ACBD-D423AC8FC2F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3" t="1450" r="1422" b="15559"/>
          <a:stretch/>
        </p:blipFill>
        <p:spPr bwMode="auto">
          <a:xfrm>
            <a:off x="1613196" y="3243263"/>
            <a:ext cx="2634954" cy="19526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6" descr="The SGPlot Procedure">
            <a:extLst>
              <a:ext uri="{FF2B5EF4-FFF2-40B4-BE49-F238E27FC236}">
                <a16:creationId xmlns:a16="http://schemas.microsoft.com/office/drawing/2014/main" id="{C8B58053-BCA5-4358-9EE5-38DF5241775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1" t="1630" r="793" b="16740"/>
          <a:stretch/>
        </p:blipFill>
        <p:spPr bwMode="auto">
          <a:xfrm>
            <a:off x="4482168" y="3248026"/>
            <a:ext cx="2687476" cy="1947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7" descr="The SGPlot Procedure">
            <a:extLst>
              <a:ext uri="{FF2B5EF4-FFF2-40B4-BE49-F238E27FC236}">
                <a16:creationId xmlns:a16="http://schemas.microsoft.com/office/drawing/2014/main" id="{F0D169AB-F4F3-4529-9852-2BC76262B74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1" t="1483" r="1689" b="16117"/>
          <a:stretch/>
        </p:blipFill>
        <p:spPr bwMode="auto">
          <a:xfrm>
            <a:off x="7415212" y="3243263"/>
            <a:ext cx="2613467" cy="1947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426E72E3-768A-49BF-92BC-52A7C349B790}"/>
              </a:ext>
            </a:extLst>
          </p:cNvPr>
          <p:cNvSpPr txBox="1"/>
          <p:nvPr/>
        </p:nvSpPr>
        <p:spPr>
          <a:xfrm>
            <a:off x="7508621" y="5191127"/>
            <a:ext cx="2558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ime From Diagnosis to Last Contact or Death (Months)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116CEB-2435-4F8F-9BF8-C88F97B9F128}"/>
              </a:ext>
            </a:extLst>
          </p:cNvPr>
          <p:cNvSpPr txBox="1"/>
          <p:nvPr/>
        </p:nvSpPr>
        <p:spPr>
          <a:xfrm>
            <a:off x="4633488" y="5191127"/>
            <a:ext cx="2558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ime From Diagnosis to Last Contact or Death (Months)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346AB2A-009E-48E9-896F-03CFB2806A5A}"/>
              </a:ext>
            </a:extLst>
          </p:cNvPr>
          <p:cNvSpPr txBox="1"/>
          <p:nvPr/>
        </p:nvSpPr>
        <p:spPr>
          <a:xfrm>
            <a:off x="1811949" y="5191127"/>
            <a:ext cx="2558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ime From Diagnosis to Last Contact or Death (Months)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E2D7651-3B8A-40CC-93B2-508B82E8C95A}"/>
              </a:ext>
            </a:extLst>
          </p:cNvPr>
          <p:cNvSpPr txBox="1"/>
          <p:nvPr/>
        </p:nvSpPr>
        <p:spPr>
          <a:xfrm>
            <a:off x="7511501" y="2742149"/>
            <a:ext cx="2558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ime From Diagnosis to Last Contact or Death (Months)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7C8C18B-B118-4969-BD9D-E00C4A829791}"/>
              </a:ext>
            </a:extLst>
          </p:cNvPr>
          <p:cNvSpPr txBox="1"/>
          <p:nvPr/>
        </p:nvSpPr>
        <p:spPr>
          <a:xfrm>
            <a:off x="4570749" y="2742149"/>
            <a:ext cx="2558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ime From Diagnosis to Last Contact or Death (Months)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C49B62C-CE16-4C8F-B235-1872593343C0}"/>
              </a:ext>
            </a:extLst>
          </p:cNvPr>
          <p:cNvSpPr txBox="1"/>
          <p:nvPr/>
        </p:nvSpPr>
        <p:spPr>
          <a:xfrm>
            <a:off x="1651316" y="2740819"/>
            <a:ext cx="25587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Time From Diagnosis to Last Contact or Death (Months)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2B57878-CC1F-4EF4-8888-A43D092364FC}"/>
              </a:ext>
            </a:extLst>
          </p:cNvPr>
          <p:cNvSpPr txBox="1"/>
          <p:nvPr/>
        </p:nvSpPr>
        <p:spPr>
          <a:xfrm rot="16200000">
            <a:off x="6653157" y="1625906"/>
            <a:ext cx="13099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Survival Function Estimat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902E7E4-F3D7-493D-B774-25867D5588BB}"/>
              </a:ext>
            </a:extLst>
          </p:cNvPr>
          <p:cNvSpPr txBox="1"/>
          <p:nvPr/>
        </p:nvSpPr>
        <p:spPr>
          <a:xfrm rot="16200000">
            <a:off x="919553" y="4154682"/>
            <a:ext cx="13099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Survival Function Estimat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318B492-31A2-43CB-AB52-BA7D0911CCB8}"/>
              </a:ext>
            </a:extLst>
          </p:cNvPr>
          <p:cNvSpPr txBox="1"/>
          <p:nvPr/>
        </p:nvSpPr>
        <p:spPr>
          <a:xfrm rot="16200000">
            <a:off x="3752102" y="4109473"/>
            <a:ext cx="13099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Survival Function Estimat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FF20B07-8D0D-4916-B790-52ECF0DEE785}"/>
              </a:ext>
            </a:extLst>
          </p:cNvPr>
          <p:cNvSpPr txBox="1"/>
          <p:nvPr/>
        </p:nvSpPr>
        <p:spPr>
          <a:xfrm rot="16200000">
            <a:off x="896222" y="1585569"/>
            <a:ext cx="13099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Survival Function Estimat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C44A6BD-9371-48E1-967F-B567F6A3326D}"/>
              </a:ext>
            </a:extLst>
          </p:cNvPr>
          <p:cNvSpPr txBox="1"/>
          <p:nvPr/>
        </p:nvSpPr>
        <p:spPr>
          <a:xfrm rot="16200000">
            <a:off x="3741652" y="1585569"/>
            <a:ext cx="13023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urvival Function Estimat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712099A-8E2F-4E52-91AC-0F87798C5217}"/>
              </a:ext>
            </a:extLst>
          </p:cNvPr>
          <p:cNvSpPr txBox="1"/>
          <p:nvPr/>
        </p:nvSpPr>
        <p:spPr>
          <a:xfrm rot="16200000">
            <a:off x="6657108" y="4109473"/>
            <a:ext cx="13099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Survival Function Estimate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14EC7ED6-A804-469E-9DF4-C1351EC6D069}"/>
              </a:ext>
            </a:extLst>
          </p:cNvPr>
          <p:cNvGrpSpPr/>
          <p:nvPr/>
        </p:nvGrpSpPr>
        <p:grpSpPr>
          <a:xfrm>
            <a:off x="2023668" y="5477857"/>
            <a:ext cx="7551226" cy="270075"/>
            <a:chOff x="2023668" y="5477857"/>
            <a:chExt cx="7551226" cy="270075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0777BF8-EAAA-4949-9AD4-8BC1A9B816B9}"/>
                </a:ext>
              </a:extLst>
            </p:cNvPr>
            <p:cNvGrpSpPr/>
            <p:nvPr/>
          </p:nvGrpSpPr>
          <p:grpSpPr>
            <a:xfrm>
              <a:off x="2023668" y="5486322"/>
              <a:ext cx="3782147" cy="261610"/>
              <a:chOff x="1811948" y="5700715"/>
              <a:chExt cx="3782147" cy="261610"/>
            </a:xfrm>
          </p:grpSpPr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id="{04CB5823-A25D-43EA-9EB4-B3369F25C783}"/>
                  </a:ext>
                </a:extLst>
              </p:cNvPr>
              <p:cNvCxnSpPr/>
              <p:nvPr/>
            </p:nvCxnSpPr>
            <p:spPr>
              <a:xfrm>
                <a:off x="1811948" y="5831520"/>
                <a:ext cx="226048" cy="0"/>
              </a:xfrm>
              <a:prstGeom prst="line">
                <a:avLst/>
              </a:prstGeom>
              <a:ln w="15875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47379E3F-1830-41A4-8338-CBAB1CAB5985}"/>
                  </a:ext>
                </a:extLst>
              </p:cNvPr>
              <p:cNvSpPr txBox="1"/>
              <p:nvPr/>
            </p:nvSpPr>
            <p:spPr>
              <a:xfrm>
                <a:off x="1992021" y="5700715"/>
                <a:ext cx="36020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Primary Surgery Followed by Chemotherapy 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9FA077B-2156-4F85-8BC0-1410DCF5AF6C}"/>
                </a:ext>
              </a:extLst>
            </p:cNvPr>
            <p:cNvGrpSpPr/>
            <p:nvPr/>
          </p:nvGrpSpPr>
          <p:grpSpPr>
            <a:xfrm>
              <a:off x="5442348" y="5477857"/>
              <a:ext cx="4132546" cy="261610"/>
              <a:chOff x="1823637" y="5930098"/>
              <a:chExt cx="4132546" cy="261610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413E3375-74F5-411D-8559-067CDEA72E39}"/>
                  </a:ext>
                </a:extLst>
              </p:cNvPr>
              <p:cNvSpPr txBox="1"/>
              <p:nvPr/>
            </p:nvSpPr>
            <p:spPr>
              <a:xfrm>
                <a:off x="1974767" y="5930098"/>
                <a:ext cx="398141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/>
                  <a:t>Neoadjuvant Chemotherapy Followed by Surgery </a:t>
                </a:r>
              </a:p>
            </p:txBody>
          </p:sp>
          <p:cxnSp>
            <p:nvCxnSpPr>
              <p:cNvPr id="41" name="Straight Connector 40">
                <a:extLst>
                  <a:ext uri="{FF2B5EF4-FFF2-40B4-BE49-F238E27FC236}">
                    <a16:creationId xmlns:a16="http://schemas.microsoft.com/office/drawing/2014/main" id="{5BFEF5BD-307B-4F7A-8E5B-E007B747C876}"/>
                  </a:ext>
                </a:extLst>
              </p:cNvPr>
              <p:cNvCxnSpPr/>
              <p:nvPr/>
            </p:nvCxnSpPr>
            <p:spPr>
              <a:xfrm>
                <a:off x="1823637" y="6060903"/>
                <a:ext cx="226048" cy="0"/>
              </a:xfrm>
              <a:prstGeom prst="line">
                <a:avLst/>
              </a:prstGeom>
              <a:ln w="158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60155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D33CA6FCBEA8B43950FB984F15009B2" ma:contentTypeVersion="17" ma:contentTypeDescription="Create a new document." ma:contentTypeScope="" ma:versionID="d30ef4ac23b3a4b81fa669e3200f2506">
  <xsd:schema xmlns:xsd="http://www.w3.org/2001/XMLSchema" xmlns:xs="http://www.w3.org/2001/XMLSchema" xmlns:p="http://schemas.microsoft.com/office/2006/metadata/properties" xmlns:ns3="25b9ed3b-18f0-4231-a94d-21047cc980c6" xmlns:ns4="8689e43f-fd8c-432d-9b49-b53abf03748e" targetNamespace="http://schemas.microsoft.com/office/2006/metadata/properties" ma:root="true" ma:fieldsID="9a952293bb1aeed00c8ee4c098b8813c" ns3:_="" ns4:_="">
    <xsd:import namespace="25b9ed3b-18f0-4231-a94d-21047cc980c6"/>
    <xsd:import namespace="8689e43f-fd8c-432d-9b49-b53abf03748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bjectDetectorVersions" minOccurs="0"/>
                <xsd:element ref="ns3:_activity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b9ed3b-18f0-4231-a94d-21047cc980c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ServiceObjectDetectorVersions" ma:index="21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689e43f-fd8c-432d-9b49-b53abf03748e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5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25b9ed3b-18f0-4231-a94d-21047cc980c6" xsi:nil="true"/>
  </documentManagement>
</p:properties>
</file>

<file path=customXml/itemProps1.xml><?xml version="1.0" encoding="utf-8"?>
<ds:datastoreItem xmlns:ds="http://schemas.openxmlformats.org/officeDocument/2006/customXml" ds:itemID="{8688CFD7-6F6F-4D08-A92A-5CE90DDA4FD9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7AFF333-1950-4944-A698-46207D594F4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5b9ed3b-18f0-4231-a94d-21047cc980c6"/>
    <ds:schemaRef ds:uri="8689e43f-fd8c-432d-9b49-b53abf03748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40CE2DC9-D79A-4D24-9463-22DA41BB761B}">
  <ds:schemaRefs>
    <ds:schemaRef ds:uri="http://purl.org/dc/dcmitype/"/>
    <ds:schemaRef ds:uri="http://www.w3.org/XML/1998/namespace"/>
    <ds:schemaRef ds:uri="http://schemas.microsoft.com/office/2006/metadata/properties"/>
    <ds:schemaRef ds:uri="http://schemas.microsoft.com/office/infopath/2007/PartnerControls"/>
    <ds:schemaRef ds:uri="http://purl.org/dc/elements/1.1/"/>
    <ds:schemaRef ds:uri="http://purl.org/dc/terms/"/>
    <ds:schemaRef ds:uri="http://schemas.microsoft.com/office/2006/documentManagement/types"/>
    <ds:schemaRef ds:uri="8689e43f-fd8c-432d-9b49-b53abf03748e"/>
    <ds:schemaRef ds:uri="http://schemas.openxmlformats.org/package/2006/metadata/core-properties"/>
    <ds:schemaRef ds:uri="25b9ed3b-18f0-4231-a94d-21047cc980c6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332</TotalTime>
  <Words>397</Words>
  <Application>Microsoft Office PowerPoint</Application>
  <PresentationFormat>Widescreen</PresentationFormat>
  <Paragraphs>6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, Yongmei</dc:creator>
  <cp:lastModifiedBy>Huang, Yongmei</cp:lastModifiedBy>
  <cp:revision>37</cp:revision>
  <dcterms:created xsi:type="dcterms:W3CDTF">2024-06-04T14:28:12Z</dcterms:created>
  <dcterms:modified xsi:type="dcterms:W3CDTF">2024-09-26T18:29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D33CA6FCBEA8B43950FB984F15009B2</vt:lpwstr>
  </property>
</Properties>
</file>